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7199313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14" userDrawn="1">
          <p15:clr>
            <a:srgbClr val="A4A3A4"/>
          </p15:clr>
        </p15:guide>
        <p15:guide id="2" pos="22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24" d="100"/>
          <a:sy n="124" d="100"/>
        </p:scale>
        <p:origin x="1902" y="90"/>
      </p:cViewPr>
      <p:guideLst>
        <p:guide orient="horz" pos="1814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BBD965-5108-4613-B790-4EEEC2499876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CEB842-17C3-4D89-8946-3244251C27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8222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1pPr>
    <a:lvl2pPr marL="345564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2pPr>
    <a:lvl3pPr marL="691129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3pPr>
    <a:lvl4pPr marL="1036693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4pPr>
    <a:lvl5pPr marL="1382258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5pPr>
    <a:lvl6pPr marL="1727822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6pPr>
    <a:lvl7pPr marL="2073387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7pPr>
    <a:lvl8pPr marL="2418951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8pPr>
    <a:lvl9pPr marL="2764516" algn="l" defTabSz="691129" rtl="0" eaLnBrk="1" latinLnBrk="0" hangingPunct="1">
      <a:defRPr sz="9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500188" y="1143000"/>
            <a:ext cx="38576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CEB842-17C3-4D89-8946-3244251C273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15165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942577"/>
            <a:ext cx="6119416" cy="2005142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025045"/>
            <a:ext cx="5399485" cy="1390533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1281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6863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06637"/>
            <a:ext cx="1552352" cy="488086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06637"/>
            <a:ext cx="4567064" cy="488086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720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2479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435864"/>
            <a:ext cx="6209407" cy="2395771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3854300"/>
            <a:ext cx="6209407" cy="1259879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5414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533187"/>
            <a:ext cx="3059708" cy="36543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533187"/>
            <a:ext cx="3059708" cy="36543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4987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06639"/>
            <a:ext cx="6209407" cy="111322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411865"/>
            <a:ext cx="3045646" cy="69193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103799"/>
            <a:ext cx="3045646" cy="309437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411865"/>
            <a:ext cx="3060646" cy="69193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103799"/>
            <a:ext cx="3060646" cy="309437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1818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4794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2430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83963"/>
            <a:ext cx="2321966" cy="1343872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829256"/>
            <a:ext cx="3644652" cy="409294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727835"/>
            <a:ext cx="2321966" cy="320102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137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83963"/>
            <a:ext cx="2321966" cy="1343872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829256"/>
            <a:ext cx="3644652" cy="409294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727835"/>
            <a:ext cx="2321966" cy="320102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4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06639"/>
            <a:ext cx="6209407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533187"/>
            <a:ext cx="6209407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5338158"/>
            <a:ext cx="1619845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BD951-F117-41B0-B327-D459893F06B5}" type="datetimeFigureOut">
              <a:rPr lang="zh-CN" altLang="en-US" smtClean="0"/>
              <a:t>2022/3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5338158"/>
            <a:ext cx="2429768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5338158"/>
            <a:ext cx="1619845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92356-716D-4EB5-A22E-151F81773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8620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组合 55">
            <a:extLst>
              <a:ext uri="{FF2B5EF4-FFF2-40B4-BE49-F238E27FC236}">
                <a16:creationId xmlns:a16="http://schemas.microsoft.com/office/drawing/2014/main" id="{8917EAD4-C645-453F-A9BB-A65D67D28698}"/>
              </a:ext>
            </a:extLst>
          </p:cNvPr>
          <p:cNvGrpSpPr>
            <a:grpSpLocks noChangeAspect="1"/>
          </p:cNvGrpSpPr>
          <p:nvPr/>
        </p:nvGrpSpPr>
        <p:grpSpPr>
          <a:xfrm>
            <a:off x="335470" y="647477"/>
            <a:ext cx="6455076" cy="4966303"/>
            <a:chOff x="335470" y="647477"/>
            <a:chExt cx="6455076" cy="4966303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3D7E2EA8-8FDD-4372-B50B-3BA4F59D6A13}"/>
                </a:ext>
              </a:extLst>
            </p:cNvPr>
            <p:cNvGrpSpPr/>
            <p:nvPr/>
          </p:nvGrpSpPr>
          <p:grpSpPr>
            <a:xfrm>
              <a:off x="3599656" y="677026"/>
              <a:ext cx="3187393" cy="2425022"/>
              <a:chOff x="6731972" y="7031747"/>
              <a:chExt cx="2988840" cy="2273959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A3DF255B-BF19-4C74-BD99-58EADADA1B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40000"/>
                        </a14:imgEffect>
                        <a14:imgEffect>
                          <a14:brightnessContrast bright="6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19" t="5905" r="22144" b="7650"/>
              <a:stretch/>
            </p:blipFill>
            <p:spPr>
              <a:xfrm>
                <a:off x="6731972" y="7031747"/>
                <a:ext cx="2988840" cy="2273959"/>
              </a:xfrm>
              <a:prstGeom prst="rect">
                <a:avLst/>
              </a:prstGeom>
            </p:spPr>
          </p:pic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66A401E3-5651-4F62-AD70-DF223706E51A}"/>
                  </a:ext>
                </a:extLst>
              </p:cNvPr>
              <p:cNvSpPr/>
              <p:nvPr/>
            </p:nvSpPr>
            <p:spPr>
              <a:xfrm>
                <a:off x="9112064" y="9083069"/>
                <a:ext cx="591538" cy="36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920" dirty="0"/>
              </a:p>
            </p:txBody>
          </p:sp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1B40A2BC-414B-4A18-97B3-1C3AB3FB2471}"/>
                  </a:ext>
                </a:extLst>
              </p:cNvPr>
              <p:cNvGrpSpPr/>
              <p:nvPr/>
            </p:nvGrpSpPr>
            <p:grpSpPr>
              <a:xfrm>
                <a:off x="7201588" y="8239667"/>
                <a:ext cx="1155320" cy="498273"/>
                <a:chOff x="3897283" y="4506472"/>
                <a:chExt cx="1155320" cy="498273"/>
              </a:xfrm>
            </p:grpSpPr>
            <p:cxnSp>
              <p:nvCxnSpPr>
                <p:cNvPr id="11" name="直接连接符 10">
                  <a:extLst>
                    <a:ext uri="{FF2B5EF4-FFF2-40B4-BE49-F238E27FC236}">
                      <a16:creationId xmlns:a16="http://schemas.microsoft.com/office/drawing/2014/main" id="{59B67D18-EDE6-45E1-9061-FA654BE758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378837">
                  <a:off x="4318709" y="4506472"/>
                  <a:ext cx="346752" cy="37229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接箭头连接符 11">
                  <a:extLst>
                    <a:ext uri="{FF2B5EF4-FFF2-40B4-BE49-F238E27FC236}">
                      <a16:creationId xmlns:a16="http://schemas.microsoft.com/office/drawing/2014/main" id="{7A0F7AEF-6AD2-41DB-887F-16AA933FF2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2788021" flipH="1" flipV="1">
                  <a:off x="4387583" y="4598681"/>
                  <a:ext cx="131767" cy="173033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6DE3925D-A197-465B-A06A-B2FB30268E0C}"/>
                    </a:ext>
                  </a:extLst>
                </p:cNvPr>
                <p:cNvSpPr txBox="1"/>
                <p:nvPr/>
              </p:nvSpPr>
              <p:spPr>
                <a:xfrm rot="655476">
                  <a:off x="3897283" y="4733457"/>
                  <a:ext cx="1155320" cy="271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8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 (111) = 4.81Å</a:t>
                  </a:r>
                  <a:endParaRPr lang="zh-CN" altLang="en-US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4" name="直接连接符 13">
                  <a:extLst>
                    <a:ext uri="{FF2B5EF4-FFF2-40B4-BE49-F238E27FC236}">
                      <a16:creationId xmlns:a16="http://schemas.microsoft.com/office/drawing/2014/main" id="{E276A607-2EBC-482B-B8A5-D572C35528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378837">
                  <a:off x="4314884" y="4539003"/>
                  <a:ext cx="344051" cy="4116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641E860E-A404-47AF-BB36-663AAE69BDDB}"/>
                  </a:ext>
                </a:extLst>
              </p:cNvPr>
              <p:cNvGrpSpPr/>
              <p:nvPr/>
            </p:nvGrpSpPr>
            <p:grpSpPr>
              <a:xfrm>
                <a:off x="7976222" y="7390703"/>
                <a:ext cx="532974" cy="1243402"/>
                <a:chOff x="4671917" y="3657508"/>
                <a:chExt cx="532974" cy="1243402"/>
              </a:xfrm>
            </p:grpSpPr>
            <p:cxnSp>
              <p:nvCxnSpPr>
                <p:cNvPr id="7" name="直接连接符 6">
                  <a:extLst>
                    <a:ext uri="{FF2B5EF4-FFF2-40B4-BE49-F238E27FC236}">
                      <a16:creationId xmlns:a16="http://schemas.microsoft.com/office/drawing/2014/main" id="{88B365E4-2D94-487C-AFED-A9B8F36FD1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517156" y="4340892"/>
                  <a:ext cx="346752" cy="37229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直接箭头连接符 7">
                  <a:extLst>
                    <a:ext uri="{FF2B5EF4-FFF2-40B4-BE49-F238E27FC236}">
                      <a16:creationId xmlns:a16="http://schemas.microsoft.com/office/drawing/2014/main" id="{F7978066-64BE-41CA-90B3-7A3FC2B8FB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4745309" y="4374852"/>
                  <a:ext cx="205475" cy="41677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5BFFFDC7-1971-41B5-BD1A-491732A85C2C}"/>
                    </a:ext>
                  </a:extLst>
                </p:cNvPr>
                <p:cNvSpPr txBox="1"/>
                <p:nvPr/>
              </p:nvSpPr>
              <p:spPr>
                <a:xfrm rot="16476639">
                  <a:off x="4447546" y="4143565"/>
                  <a:ext cx="1243402" cy="271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8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 (022) = 2.909Å</a:t>
                  </a:r>
                  <a:endParaRPr lang="zh-CN" altLang="en-US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0" name="直接连接符 9">
                  <a:extLst>
                    <a:ext uri="{FF2B5EF4-FFF2-40B4-BE49-F238E27FC236}">
                      <a16:creationId xmlns:a16="http://schemas.microsoft.com/office/drawing/2014/main" id="{500D7883-5A3B-47A1-9E92-D11FD36D32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4553367" y="4340273"/>
                  <a:ext cx="344051" cy="4116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4F2258E3-64C8-4F0E-B166-3E2AEDF76451}"/>
                </a:ext>
              </a:extLst>
            </p:cNvPr>
            <p:cNvGrpSpPr/>
            <p:nvPr/>
          </p:nvGrpSpPr>
          <p:grpSpPr>
            <a:xfrm>
              <a:off x="335472" y="677026"/>
              <a:ext cx="3187393" cy="2422505"/>
              <a:chOff x="6731973" y="9368824"/>
              <a:chExt cx="2988840" cy="2271599"/>
            </a:xfrm>
          </p:grpSpPr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41BD77C3-B178-4351-8F0C-12C462A7B2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4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89" t="26244" r="38549" b="2253"/>
              <a:stretch/>
            </p:blipFill>
            <p:spPr>
              <a:xfrm>
                <a:off x="6731973" y="9368824"/>
                <a:ext cx="2988840" cy="2271599"/>
              </a:xfrm>
              <a:prstGeom prst="rect">
                <a:avLst/>
              </a:prstGeom>
            </p:spPr>
          </p:pic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7034945D-C677-4ABE-9AC1-1895C6F44E4D}"/>
                  </a:ext>
                </a:extLst>
              </p:cNvPr>
              <p:cNvSpPr/>
              <p:nvPr/>
            </p:nvSpPr>
            <p:spPr>
              <a:xfrm>
                <a:off x="8945454" y="11471601"/>
                <a:ext cx="758148" cy="36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92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" name="组合 17">
                <a:extLst>
                  <a:ext uri="{FF2B5EF4-FFF2-40B4-BE49-F238E27FC236}">
                    <a16:creationId xmlns:a16="http://schemas.microsoft.com/office/drawing/2014/main" id="{7E71AAE8-D307-4FD1-8F8E-F8BAE796C273}"/>
                  </a:ext>
                </a:extLst>
              </p:cNvPr>
              <p:cNvGrpSpPr/>
              <p:nvPr/>
            </p:nvGrpSpPr>
            <p:grpSpPr>
              <a:xfrm>
                <a:off x="7626715" y="9796963"/>
                <a:ext cx="1243403" cy="574062"/>
                <a:chOff x="4323586" y="6056523"/>
                <a:chExt cx="1243403" cy="574062"/>
              </a:xfrm>
            </p:grpSpPr>
            <p:cxnSp>
              <p:nvCxnSpPr>
                <p:cNvPr id="24" name="直接箭头连接符 23">
                  <a:extLst>
                    <a:ext uri="{FF2B5EF4-FFF2-40B4-BE49-F238E27FC236}">
                      <a16:creationId xmlns:a16="http://schemas.microsoft.com/office/drawing/2014/main" id="{89305906-9197-4747-A0CA-1C2E206721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949580" y="6317234"/>
                  <a:ext cx="5038" cy="250914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018205C5-ED1F-4907-B298-8D14619A4BB6}"/>
                    </a:ext>
                  </a:extLst>
                </p:cNvPr>
                <p:cNvSpPr txBox="1"/>
                <p:nvPr/>
              </p:nvSpPr>
              <p:spPr>
                <a:xfrm>
                  <a:off x="4323586" y="6056523"/>
                  <a:ext cx="1243403" cy="271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8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 (022) = 2.932Å</a:t>
                  </a:r>
                  <a:endParaRPr lang="zh-CN" altLang="en-US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6" name="直接连接符 25">
                  <a:extLst>
                    <a:ext uri="{FF2B5EF4-FFF2-40B4-BE49-F238E27FC236}">
                      <a16:creationId xmlns:a16="http://schemas.microsoft.com/office/drawing/2014/main" id="{78269EDA-0D94-4043-B42E-150AE99386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167382" flipV="1">
                  <a:off x="4941668" y="6453499"/>
                  <a:ext cx="27442" cy="32673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直接连接符 26">
                  <a:extLst>
                    <a:ext uri="{FF2B5EF4-FFF2-40B4-BE49-F238E27FC236}">
                      <a16:creationId xmlns:a16="http://schemas.microsoft.com/office/drawing/2014/main" id="{E0D7CB9B-C90E-49FD-AFBF-D40BB88B77A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167382" flipV="1">
                  <a:off x="4941708" y="6412551"/>
                  <a:ext cx="27442" cy="32673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7C74EBB7-B98B-4EA3-8054-3AD535A472BA}"/>
                  </a:ext>
                </a:extLst>
              </p:cNvPr>
              <p:cNvGrpSpPr/>
              <p:nvPr/>
            </p:nvGrpSpPr>
            <p:grpSpPr>
              <a:xfrm>
                <a:off x="7502311" y="9933191"/>
                <a:ext cx="586516" cy="1243402"/>
                <a:chOff x="4199182" y="6192751"/>
                <a:chExt cx="586516" cy="1243402"/>
              </a:xfrm>
            </p:grpSpPr>
            <p:cxnSp>
              <p:nvCxnSpPr>
                <p:cNvPr id="20" name="直接连接符 19">
                  <a:extLst>
                    <a:ext uri="{FF2B5EF4-FFF2-40B4-BE49-F238E27FC236}">
                      <a16:creationId xmlns:a16="http://schemas.microsoft.com/office/drawing/2014/main" id="{082A7837-7E4B-46F8-9486-895240FC3D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0535288" flipV="1">
                  <a:off x="4755009" y="6617175"/>
                  <a:ext cx="30689" cy="324556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箭头连接符 20">
                  <a:extLst>
                    <a:ext uri="{FF2B5EF4-FFF2-40B4-BE49-F238E27FC236}">
                      <a16:creationId xmlns:a16="http://schemas.microsoft.com/office/drawing/2014/main" id="{A036D943-B2A2-4264-B9DD-2E787499BC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135288" flipV="1">
                  <a:off x="4591418" y="6683038"/>
                  <a:ext cx="13312" cy="224513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F4AD4879-3BDF-4C42-9DC4-2FB593A8ED0D}"/>
                    </a:ext>
                  </a:extLst>
                </p:cNvPr>
                <p:cNvSpPr txBox="1"/>
                <p:nvPr/>
              </p:nvSpPr>
              <p:spPr>
                <a:xfrm rot="5400000">
                  <a:off x="3713125" y="6678808"/>
                  <a:ext cx="1243402" cy="271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8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 (022) = 2.901Å</a:t>
                  </a:r>
                  <a:endParaRPr lang="zh-CN" altLang="en-US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3" name="直接连接符 22">
                  <a:extLst>
                    <a:ext uri="{FF2B5EF4-FFF2-40B4-BE49-F238E27FC236}">
                      <a16:creationId xmlns:a16="http://schemas.microsoft.com/office/drawing/2014/main" id="{4A3DAF86-433D-465C-B79F-68AA9CC139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0535288" flipV="1">
                  <a:off x="4721407" y="6617187"/>
                  <a:ext cx="27442" cy="32673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D35056D8-1A57-47DE-96B7-EF3F6E72DFF3}"/>
                </a:ext>
              </a:extLst>
            </p:cNvPr>
            <p:cNvGrpSpPr/>
            <p:nvPr/>
          </p:nvGrpSpPr>
          <p:grpSpPr>
            <a:xfrm>
              <a:off x="335470" y="3188674"/>
              <a:ext cx="3187393" cy="2424830"/>
              <a:chOff x="3428844" y="8063037"/>
              <a:chExt cx="2988840" cy="2273778"/>
            </a:xfrm>
          </p:grpSpPr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B5BEE75C-B3C2-43EC-949A-5172E554C9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81" t="2113" r="18524" b="9889"/>
              <a:stretch/>
            </p:blipFill>
            <p:spPr>
              <a:xfrm>
                <a:off x="3428844" y="8063037"/>
                <a:ext cx="2988840" cy="2273778"/>
              </a:xfrm>
              <a:prstGeom prst="rect">
                <a:avLst/>
              </a:prstGeom>
            </p:spPr>
          </p:pic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C00A7E3B-5C21-48E6-8FF4-8E95DC250772}"/>
                  </a:ext>
                </a:extLst>
              </p:cNvPr>
              <p:cNvSpPr/>
              <p:nvPr/>
            </p:nvSpPr>
            <p:spPr>
              <a:xfrm>
                <a:off x="5777888" y="10199331"/>
                <a:ext cx="569671" cy="36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920"/>
              </a:p>
            </p:txBody>
          </p:sp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86CE4D72-6DD1-47CF-A23C-F560333935DB}"/>
                  </a:ext>
                </a:extLst>
              </p:cNvPr>
              <p:cNvGrpSpPr/>
              <p:nvPr/>
            </p:nvGrpSpPr>
            <p:grpSpPr>
              <a:xfrm>
                <a:off x="3907917" y="8699122"/>
                <a:ext cx="566682" cy="1231978"/>
                <a:chOff x="3907917" y="8699122"/>
                <a:chExt cx="566682" cy="1231978"/>
              </a:xfrm>
            </p:grpSpPr>
            <p:cxnSp>
              <p:nvCxnSpPr>
                <p:cNvPr id="37" name="直接连接符 36">
                  <a:extLst>
                    <a:ext uri="{FF2B5EF4-FFF2-40B4-BE49-F238E27FC236}">
                      <a16:creationId xmlns:a16="http://schemas.microsoft.com/office/drawing/2014/main" id="{CE22D9B7-F43B-428B-92B4-7D085551D7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4620673">
                  <a:off x="4282609" y="9215980"/>
                  <a:ext cx="346752" cy="37229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接箭头连接符 37">
                  <a:extLst>
                    <a:ext uri="{FF2B5EF4-FFF2-40B4-BE49-F238E27FC236}">
                      <a16:creationId xmlns:a16="http://schemas.microsoft.com/office/drawing/2014/main" id="{26011143-BDBC-4396-B42A-93D4F39E49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20820673">
                  <a:off x="4173379" y="9243264"/>
                  <a:ext cx="216050" cy="33964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1ABDE36F-D880-4DE0-B8E8-7C019D48B416}"/>
                    </a:ext>
                  </a:extLst>
                </p:cNvPr>
                <p:cNvSpPr txBox="1"/>
                <p:nvPr/>
              </p:nvSpPr>
              <p:spPr>
                <a:xfrm rot="4897312">
                  <a:off x="3427572" y="9179467"/>
                  <a:ext cx="1231978" cy="271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8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 (111) = 4.882Å</a:t>
                  </a:r>
                  <a:endParaRPr lang="zh-CN" altLang="en-US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0" name="直接连接符 39">
                  <a:extLst>
                    <a:ext uri="{FF2B5EF4-FFF2-40B4-BE49-F238E27FC236}">
                      <a16:creationId xmlns:a16="http://schemas.microsoft.com/office/drawing/2014/main" id="{55106D01-CB56-4D75-B7F7-6B524C3859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4620673">
                  <a:off x="4249688" y="9220529"/>
                  <a:ext cx="344051" cy="4116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" name="组合 31">
                <a:extLst>
                  <a:ext uri="{FF2B5EF4-FFF2-40B4-BE49-F238E27FC236}">
                    <a16:creationId xmlns:a16="http://schemas.microsoft.com/office/drawing/2014/main" id="{8CED5DE7-AAF1-476F-AC65-3404A40DF2C9}"/>
                  </a:ext>
                </a:extLst>
              </p:cNvPr>
              <p:cNvGrpSpPr/>
              <p:nvPr/>
            </p:nvGrpSpPr>
            <p:grpSpPr>
              <a:xfrm>
                <a:off x="4161893" y="9341892"/>
                <a:ext cx="1243403" cy="481580"/>
                <a:chOff x="4161893" y="9341892"/>
                <a:chExt cx="1243403" cy="481580"/>
              </a:xfrm>
            </p:grpSpPr>
            <p:cxnSp>
              <p:nvCxnSpPr>
                <p:cNvPr id="33" name="直接连接符 32">
                  <a:extLst>
                    <a:ext uri="{FF2B5EF4-FFF2-40B4-BE49-F238E27FC236}">
                      <a16:creationId xmlns:a16="http://schemas.microsoft.com/office/drawing/2014/main" id="{4C1693D7-92F0-470B-A744-5183C2DF9C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20719317">
                  <a:off x="4502986" y="9341892"/>
                  <a:ext cx="346752" cy="37229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箭头连接符 33">
                  <a:extLst>
                    <a:ext uri="{FF2B5EF4-FFF2-40B4-BE49-F238E27FC236}">
                      <a16:creationId xmlns:a16="http://schemas.microsoft.com/office/drawing/2014/main" id="{5C50EF65-B87E-46AB-87AF-0BDDD8251A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528501" flipH="1" flipV="1">
                  <a:off x="4631780" y="9437309"/>
                  <a:ext cx="131767" cy="173033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05962CFF-C05A-449E-9F0A-78E67C09A1D7}"/>
                    </a:ext>
                  </a:extLst>
                </p:cNvPr>
                <p:cNvSpPr txBox="1"/>
                <p:nvPr/>
              </p:nvSpPr>
              <p:spPr>
                <a:xfrm rot="20995956">
                  <a:off x="4161893" y="9552184"/>
                  <a:ext cx="1243403" cy="2712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8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 (220) = 2.933Å</a:t>
                  </a:r>
                  <a:endParaRPr lang="zh-CN" altLang="en-US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6" name="直接连接符 35">
                  <a:extLst>
                    <a:ext uri="{FF2B5EF4-FFF2-40B4-BE49-F238E27FC236}">
                      <a16:creationId xmlns:a16="http://schemas.microsoft.com/office/drawing/2014/main" id="{4C1590AB-1C69-45B1-82DA-981FB17583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20719317">
                  <a:off x="4511863" y="9373987"/>
                  <a:ext cx="344051" cy="4116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DB7F6E94-6CBD-421B-A0D3-3F78CB7CA1AC}"/>
                </a:ext>
              </a:extLst>
            </p:cNvPr>
            <p:cNvGrpSpPr/>
            <p:nvPr/>
          </p:nvGrpSpPr>
          <p:grpSpPr>
            <a:xfrm>
              <a:off x="3599657" y="3195942"/>
              <a:ext cx="3190889" cy="2417838"/>
              <a:chOff x="3421577" y="973893"/>
              <a:chExt cx="3110077" cy="2356604"/>
            </a:xfrm>
          </p:grpSpPr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7D8804A2-E10A-4ABF-8243-C87F57ED60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20000"/>
                        </a14:imgEffect>
                        <a14:imgEffect>
                          <a14:brightnessContrast bright="1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155" t="2800" r="32374" b="3492"/>
              <a:stretch/>
            </p:blipFill>
            <p:spPr>
              <a:xfrm rot="5400000">
                <a:off x="3798314" y="597156"/>
                <a:ext cx="2356604" cy="3110077"/>
              </a:xfrm>
              <a:prstGeom prst="rect">
                <a:avLst/>
              </a:prstGeom>
            </p:spPr>
          </p:pic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1E51A64C-AF8C-4FEC-BBFD-2B025BBA5734}"/>
                  </a:ext>
                </a:extLst>
              </p:cNvPr>
              <p:cNvSpPr/>
              <p:nvPr/>
            </p:nvSpPr>
            <p:spPr>
              <a:xfrm>
                <a:off x="5507330" y="3124764"/>
                <a:ext cx="929977" cy="36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altLang="zh-CN" sz="1920" dirty="0"/>
              </a:p>
            </p:txBody>
          </p:sp>
          <p:cxnSp>
            <p:nvCxnSpPr>
              <p:cNvPr id="44" name="直接连接符 43">
                <a:extLst>
                  <a:ext uri="{FF2B5EF4-FFF2-40B4-BE49-F238E27FC236}">
                    <a16:creationId xmlns:a16="http://schemas.microsoft.com/office/drawing/2014/main" id="{8352FD4C-4196-428E-B0FE-C66341EE681A}"/>
                  </a:ext>
                </a:extLst>
              </p:cNvPr>
              <p:cNvCxnSpPr>
                <a:cxnSpLocks/>
              </p:cNvCxnSpPr>
              <p:nvPr/>
            </p:nvCxnSpPr>
            <p:spPr>
              <a:xfrm rot="19190816">
                <a:off x="5067774" y="2278681"/>
                <a:ext cx="346752" cy="3722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箭头连接符 44">
                <a:extLst>
                  <a:ext uri="{FF2B5EF4-FFF2-40B4-BE49-F238E27FC236}">
                    <a16:creationId xmlns:a16="http://schemas.microsoft.com/office/drawing/2014/main" id="{F8397F06-25A9-409E-9543-F0E3CE4533E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264744" y="2349057"/>
                <a:ext cx="131767" cy="17303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F3261A0F-C411-4166-878B-E31792C281DC}"/>
                  </a:ext>
                </a:extLst>
              </p:cNvPr>
              <p:cNvSpPr txBox="1"/>
              <p:nvPr/>
            </p:nvSpPr>
            <p:spPr>
              <a:xfrm rot="19467455">
                <a:off x="4878307" y="2405681"/>
                <a:ext cx="1200866" cy="2819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 (111) = 4.82Å</a:t>
                </a:r>
                <a:endParaRPr lang="zh-CN" altLang="en-US" sz="128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C0737D30-ACB6-40CC-9D8F-1494CCB26507}"/>
                  </a:ext>
                </a:extLst>
              </p:cNvPr>
              <p:cNvCxnSpPr>
                <a:cxnSpLocks/>
              </p:cNvCxnSpPr>
              <p:nvPr/>
            </p:nvCxnSpPr>
            <p:spPr>
              <a:xfrm rot="19190816">
                <a:off x="5090572" y="2304227"/>
                <a:ext cx="344051" cy="41168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96F2AF95-A136-494C-8682-5F4BBF8B1E37}"/>
                  </a:ext>
                </a:extLst>
              </p:cNvPr>
              <p:cNvCxnSpPr>
                <a:cxnSpLocks/>
              </p:cNvCxnSpPr>
              <p:nvPr/>
            </p:nvCxnSpPr>
            <p:spPr>
              <a:xfrm rot="12807269">
                <a:off x="5086410" y="2046237"/>
                <a:ext cx="346752" cy="37229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箭头连接符 48">
                <a:extLst>
                  <a:ext uri="{FF2B5EF4-FFF2-40B4-BE49-F238E27FC236}">
                    <a16:creationId xmlns:a16="http://schemas.microsoft.com/office/drawing/2014/main" id="{7BCDC098-E4E1-414D-A921-334F9C1CC1D9}"/>
                  </a:ext>
                </a:extLst>
              </p:cNvPr>
              <p:cNvCxnSpPr>
                <a:cxnSpLocks/>
              </p:cNvCxnSpPr>
              <p:nvPr/>
            </p:nvCxnSpPr>
            <p:spPr>
              <a:xfrm rot="15216453" flipH="1" flipV="1">
                <a:off x="5301308" y="1853471"/>
                <a:ext cx="131767" cy="17303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0FA57025-EA76-4C4F-B041-B017FBE4D99E}"/>
                  </a:ext>
                </a:extLst>
              </p:cNvPr>
              <p:cNvSpPr txBox="1"/>
              <p:nvPr/>
            </p:nvSpPr>
            <p:spPr>
              <a:xfrm rot="2216790">
                <a:off x="4904124" y="1620431"/>
                <a:ext cx="1200866" cy="2819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 (111) = 4.82Å</a:t>
                </a:r>
                <a:endParaRPr lang="zh-CN" altLang="en-US" sz="128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1" name="直接连接符 50">
                <a:extLst>
                  <a:ext uri="{FF2B5EF4-FFF2-40B4-BE49-F238E27FC236}">
                    <a16:creationId xmlns:a16="http://schemas.microsoft.com/office/drawing/2014/main" id="{F1937605-082E-4FEB-97D4-9AB51DB797F9}"/>
                  </a:ext>
                </a:extLst>
              </p:cNvPr>
              <p:cNvCxnSpPr>
                <a:cxnSpLocks/>
              </p:cNvCxnSpPr>
              <p:nvPr/>
            </p:nvCxnSpPr>
            <p:spPr>
              <a:xfrm rot="12807269">
                <a:off x="5108105" y="2015928"/>
                <a:ext cx="344051" cy="41168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2215A8D3-0FEF-4A8A-81FE-997B48F66BFC}"/>
                </a:ext>
              </a:extLst>
            </p:cNvPr>
            <p:cNvSpPr txBox="1"/>
            <p:nvPr/>
          </p:nvSpPr>
          <p:spPr>
            <a:xfrm>
              <a:off x="335470" y="647477"/>
              <a:ext cx="230375" cy="3877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9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92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D5D99FC8-FEFB-4776-9C01-E0E5352DB473}"/>
                </a:ext>
              </a:extLst>
            </p:cNvPr>
            <p:cNvSpPr txBox="1"/>
            <p:nvPr/>
          </p:nvSpPr>
          <p:spPr>
            <a:xfrm>
              <a:off x="3632927" y="647477"/>
              <a:ext cx="230375" cy="3877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9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92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8AB2CB2D-6E63-424D-8843-A18752B6B129}"/>
                </a:ext>
              </a:extLst>
            </p:cNvPr>
            <p:cNvSpPr txBox="1"/>
            <p:nvPr/>
          </p:nvSpPr>
          <p:spPr>
            <a:xfrm>
              <a:off x="335470" y="3159127"/>
              <a:ext cx="230375" cy="3877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9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92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315461D5-5465-49BB-BC8A-3FDDFDBB1D0D}"/>
                </a:ext>
              </a:extLst>
            </p:cNvPr>
            <p:cNvSpPr txBox="1"/>
            <p:nvPr/>
          </p:nvSpPr>
          <p:spPr>
            <a:xfrm>
              <a:off x="3632927" y="3159127"/>
              <a:ext cx="230375" cy="3877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9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92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7" name="文本框 56">
            <a:extLst>
              <a:ext uri="{FF2B5EF4-FFF2-40B4-BE49-F238E27FC236}">
                <a16:creationId xmlns:a16="http://schemas.microsoft.com/office/drawing/2014/main" id="{E5444615-81AD-40A8-A15D-5C4E6911BE4D}"/>
              </a:ext>
            </a:extLst>
          </p:cNvPr>
          <p:cNvSpPr txBox="1"/>
          <p:nvPr/>
        </p:nvSpPr>
        <p:spPr>
          <a:xfrm>
            <a:off x="244742" y="213192"/>
            <a:ext cx="68634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gnetofossil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moderate corrosion.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cale bars: </a:t>
            </a:r>
            <a:r>
              <a:rPr lang="pt-BR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B, C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pt-BR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nm, D: 20nm.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623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77</Words>
  <Application>Microsoft Office PowerPoint</Application>
  <PresentationFormat>自定义</PresentationFormat>
  <Paragraphs>1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思</dc:creator>
  <cp:lastModifiedBy>陈 思</cp:lastModifiedBy>
  <cp:revision>4</cp:revision>
  <dcterms:created xsi:type="dcterms:W3CDTF">2022-03-27T07:14:03Z</dcterms:created>
  <dcterms:modified xsi:type="dcterms:W3CDTF">2022-03-28T01:55:23Z</dcterms:modified>
</cp:coreProperties>
</file>